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707" autoAdjust="0"/>
  </p:normalViewPr>
  <p:slideViewPr>
    <p:cSldViewPr snapToGrid="0" snapToObjects="1">
      <p:cViewPr varScale="1">
        <p:scale>
          <a:sx n="106" d="100"/>
          <a:sy n="106" d="100"/>
        </p:scale>
        <p:origin x="67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191B96FE-82EF-DF49-9702-A4B37C67986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="" xmlns:a16="http://schemas.microsoft.com/office/drawing/2014/main" id="{A325010A-BD36-B14C-9A1B-6EB6EBCA4B2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2842DC09-7C09-DE4F-9E1E-85975B4BB8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C99402-43A7-5C48-B3B2-7E8EAAF7DF95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EFF5E5EF-4145-C746-9AF5-960D29B486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E4FA76FF-C715-ED41-9141-A94548381C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B1EB5-FE7F-5A4A-B0CE-5795CF4207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43427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6CA426FB-96E7-9444-9E03-6CBA43236C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73E9835D-DF54-0841-BCB2-6479CE6360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2F10070C-04B0-214F-99A6-F30EEC9853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C99402-43A7-5C48-B3B2-7E8EAAF7DF95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57E26E0F-4F6E-0B47-974E-A6057687DB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CB77E2FA-F495-B34B-97A9-CDFFCF5545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B1EB5-FE7F-5A4A-B0CE-5795CF4207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18296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="" xmlns:a16="http://schemas.microsoft.com/office/drawing/2014/main" id="{A904C6B1-4A1C-C140-AD1A-66595D44603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63C41358-EFC1-7F4F-8EBF-BC3FD350A1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1D042A35-8130-B54B-8B56-B8E61B6879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C99402-43A7-5C48-B3B2-7E8EAAF7DF95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32CF10DD-FBD9-2748-9381-D4EE66C777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DE020246-0225-564E-B64B-AECF8E9A7E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B1EB5-FE7F-5A4A-B0CE-5795CF4207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47238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AFEBFDD6-9D7F-2A41-B399-EAC0C0B336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BA0BDECA-5015-E241-B43E-6896FC12687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46741928-A4AD-6B44-951A-D275791502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C99402-43A7-5C48-B3B2-7E8EAAF7DF95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CA7355BB-68A3-6F4B-B630-2F84CDDBDB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9593E139-17CB-0743-8A42-5CC0DB5F51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B1EB5-FE7F-5A4A-B0CE-5795CF4207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1661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75D9934A-E005-0E4D-83FC-6DB8571822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F99050C9-BCD0-B54E-9572-A3759B723D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43DA83E8-494B-BC44-B142-4A277B6FA4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C99402-43A7-5C48-B3B2-7E8EAAF7DF95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F335C760-4FCA-1647-9570-2BCCD2DE20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5BB179E7-A689-3744-813B-CB996664F3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B1EB5-FE7F-5A4A-B0CE-5795CF4207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52995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68DDC20E-7250-144A-A243-25EC49ABF8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26E6E04C-115E-754F-A060-8E6B28C41DC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A15E8D2F-B389-CC4E-A8CA-5C74E808B19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1D35AC53-C3D1-9340-8B9F-3324FF6B4E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C99402-43A7-5C48-B3B2-7E8EAAF7DF95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F82E8072-4183-AE42-A5BD-91D8A204FB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3EE9C206-ED3C-D54B-83C0-EB9EA60DBE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B1EB5-FE7F-5A4A-B0CE-5795CF4207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18892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306EABF5-3608-DC42-B6FC-21F9C65B68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F4622CE3-E5FB-284B-B47C-122036795D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5AB3089F-E8B2-BB4C-B01D-03C8DFD810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="" xmlns:a16="http://schemas.microsoft.com/office/drawing/2014/main" id="{8A2FD613-2B43-3642-813F-8206974B3C3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="" xmlns:a16="http://schemas.microsoft.com/office/drawing/2014/main" id="{A4FD0F68-9745-FF40-AE76-472C684D06F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="" xmlns:a16="http://schemas.microsoft.com/office/drawing/2014/main" id="{49D89FD3-17C7-494B-9854-BC13A9A1C6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C99402-43A7-5C48-B3B2-7E8EAAF7DF95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="" xmlns:a16="http://schemas.microsoft.com/office/drawing/2014/main" id="{F0077DCC-31A1-A443-BCE9-D96DABD80F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="" xmlns:a16="http://schemas.microsoft.com/office/drawing/2014/main" id="{09E8E08C-8763-5B4B-B779-1670070CBC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B1EB5-FE7F-5A4A-B0CE-5795CF4207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68180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83F704A9-5D74-7B4A-A17A-D27068D16D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="" xmlns:a16="http://schemas.microsoft.com/office/drawing/2014/main" id="{71ECB102-C48A-8341-AE85-2B5B200A32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C99402-43A7-5C48-B3B2-7E8EAAF7DF95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="" xmlns:a16="http://schemas.microsoft.com/office/drawing/2014/main" id="{CD03D547-E8D8-E243-BD87-B866953766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="" xmlns:a16="http://schemas.microsoft.com/office/drawing/2014/main" id="{50244D34-CD1D-EB42-88B8-2377038491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B1EB5-FE7F-5A4A-B0CE-5795CF4207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82392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="" xmlns:a16="http://schemas.microsoft.com/office/drawing/2014/main" id="{9C37612B-1C28-3849-B248-F22EE02B04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C99402-43A7-5C48-B3B2-7E8EAAF7DF95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="" xmlns:a16="http://schemas.microsoft.com/office/drawing/2014/main" id="{26588C0D-A1DE-7446-8C4E-F2197EB3BF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="" xmlns:a16="http://schemas.microsoft.com/office/drawing/2014/main" id="{545009A8-D943-D54E-B01E-6094494D99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B1EB5-FE7F-5A4A-B0CE-5795CF4207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10068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09BA0BFF-8843-9647-89FD-87BDFA6D48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ECA6B270-21B7-1947-9F6C-931F6A10499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469AABAD-29DC-8D41-982D-6EFD565251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BBC8DA8C-7E45-2440-B813-EB043A46D0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C99402-43A7-5C48-B3B2-7E8EAAF7DF95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315F60B9-6168-8542-BDF6-46FA65C45E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C3A44D09-CB7A-F047-A899-4BFEB4B3E0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B1EB5-FE7F-5A4A-B0CE-5795CF4207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37623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54E230C3-4C4C-9A41-A486-A793541F86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="" xmlns:a16="http://schemas.microsoft.com/office/drawing/2014/main" id="{BA047C16-BA02-F242-8F94-F299F499221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712AC1B9-2E17-0A41-9F71-6E740FA9C68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88BD1408-FE8E-0F4C-935B-5BDD92D69C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C99402-43A7-5C48-B3B2-7E8EAAF7DF95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A6367390-4EDE-7F4B-A9CF-D71C0863DD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6450890B-73A9-DA44-965F-6640CA7490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B1EB5-FE7F-5A4A-B0CE-5795CF4207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46210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="" xmlns:a16="http://schemas.microsoft.com/office/drawing/2014/main" id="{8A48D0A9-C04D-984A-AE4C-242EA07A65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40240CD3-4F65-BF47-8A7C-FBAC8BF815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6678911F-885E-B246-9781-DDE91DDBEAE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C99402-43A7-5C48-B3B2-7E8EAAF7DF95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25338786-4A54-D745-9783-344A11B27D5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711C661E-A007-E040-A5E1-11613836C61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3B1EB5-FE7F-5A4A-B0CE-5795CF4207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22944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="" xmlns:a16="http://schemas.microsoft.com/office/drawing/2014/main" id="{40CABDE9-49DF-9643-87F6-13CF134A390E}"/>
              </a:ext>
            </a:extLst>
          </p:cNvPr>
          <p:cNvSpPr txBox="1"/>
          <p:nvPr/>
        </p:nvSpPr>
        <p:spPr>
          <a:xfrm>
            <a:off x="452672" y="5882715"/>
            <a:ext cx="10655929" cy="7232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: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M2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macrophage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markers</a:t>
            </a:r>
          </a:p>
          <a:p>
            <a:pPr algn="just"/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Heatma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highlighting the relative expression of gene markers for M2 TAMs in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mUM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versus normal liver. All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mUM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cases were sorted by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nBAP1 status and total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immunoscore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(previously described, where total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immunoscore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of “0-3” i.e. ‘cold’ tumours are shown as “-” and “4-6” i.e. ‘hot’ tumours are marked “+.” Key: [indicates tumours from the same patient. 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R4, R34 &amp; R35 were samples from the same patient, with a 6-year difference between the two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metastasectomies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CL1 is control liver samples pool 1; CL2 is control liver samples pool 2.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="" xmlns:a16="http://schemas.microsoft.com/office/drawing/2014/main" id="{1B51000F-6ADC-F84E-8461-0DD39116CB1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02867" y="347176"/>
            <a:ext cx="5232400" cy="5511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744234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16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bat-Pospiech, Dorota</dc:creator>
  <cp:lastModifiedBy>yamini krishna</cp:lastModifiedBy>
  <cp:revision>7</cp:revision>
  <dcterms:created xsi:type="dcterms:W3CDTF">2020-08-18T06:16:51Z</dcterms:created>
  <dcterms:modified xsi:type="dcterms:W3CDTF">2020-09-17T06:50:06Z</dcterms:modified>
</cp:coreProperties>
</file>